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20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BDA27-702D-4309-9E76-85EF16F673E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6BBA87-C749-405B-8DB7-49769263A37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1" y="714358"/>
            <a:ext cx="9124936" cy="3214708"/>
            <a:chOff x="1" y="714358"/>
            <a:chExt cx="9124936" cy="3214708"/>
          </a:xfrm>
        </p:grpSpPr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1"/>
            <a:srcRect/>
            <a:stretch>
              <a:fillRect/>
            </a:stretch>
          </p:blipFill>
          <p:spPr bwMode="auto">
            <a:xfrm>
              <a:off x="6143636" y="857232"/>
              <a:ext cx="2981301" cy="30718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3143240" y="857232"/>
              <a:ext cx="2928958" cy="30631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" y="714358"/>
              <a:ext cx="3071802" cy="32147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2" name="文本框 1"/>
          <p:cNvSpPr txBox="1"/>
          <p:nvPr/>
        </p:nvSpPr>
        <p:spPr>
          <a:xfrm>
            <a:off x="837565" y="4424045"/>
            <a:ext cx="7540625" cy="1706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>
              <a:lnSpc>
                <a:spcPct val="150000"/>
              </a:lnSpc>
            </a:pPr>
            <a:r>
              <a:rPr lang="zh-CN" altLang="en-US" sz="1000" b="1">
                <a:latin typeface="Times New Roman" panose="02020603050405020304" charset="0"/>
                <a:cs typeface="Times New Roman" panose="02020603050405020304" charset="0"/>
              </a:rPr>
              <a:t>Supplementary 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F</a:t>
            </a:r>
            <a:r>
              <a:rPr lang="zh-CN" altLang="en-US" sz="1000" b="1">
                <a:latin typeface="Times New Roman" panose="02020603050405020304" charset="0"/>
                <a:cs typeface="Times New Roman" panose="02020603050405020304" charset="0"/>
              </a:rPr>
              <a:t>igure 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 Association between WBCs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counts 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and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the 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  <a:sym typeface="+mn-ea"/>
              </a:rPr>
              <a:t>risk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of 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fatal stroke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among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 participants of the Guangzhou Biobank Cohort Study, 2003-2017 (n=27811)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.</a:t>
            </a:r>
            <a:endParaRPr lang="zh-CN" altLang="en-US" sz="1000">
              <a:latin typeface="Times New Roman" panose="02020603050405020304" charset="0"/>
              <a:cs typeface="Times New Roman" panose="02020603050405020304" charset="0"/>
            </a:endParaRPr>
          </a:p>
          <a:p>
            <a:pPr>
              <a:lnSpc>
                <a:spcPct val="150000"/>
              </a:lnSpc>
            </a:pP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A, B and C plots an adjusted hazard ratio and 95% confidence interval for the WBC, neutrophil and lymphocyte count quartiles, respectively, alongside the P value for trend. The adjusted confounders included sex, age, education, occupation, diabetes, hypertension, dyslipidaemia, smoking, alcohol consumption, physical activity, body mass index, self-rated health, cancer, genitourinary disease (including nephropathy, prostatic disease, and gynaecologic diseases), chest disease (including chronic obstructive pulmonary disease, chronic bronchitis, emphysema, asthma, tuberculosis, and pneumonia) and platelet count.</a:t>
            </a:r>
            <a:endParaRPr lang="zh-CN" altLang="en-US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8</Words>
  <Application>WPS 演示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1</dc:creator>
  <cp:lastModifiedBy>Tang-SH</cp:lastModifiedBy>
  <cp:revision>11</cp:revision>
  <dcterms:created xsi:type="dcterms:W3CDTF">2021-05-31T08:59:00Z</dcterms:created>
  <dcterms:modified xsi:type="dcterms:W3CDTF">2021-10-28T00:49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